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764963269"/>
              </p:ext>
            </p:extLst>
          </p:nvPr>
        </p:nvGraphicFramePr>
        <p:xfrm>
          <a:off x="1066800" y="838200"/>
          <a:ext cx="6629400" cy="5152142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1539650"/>
                <a:gridCol w="5089750"/>
              </a:tblGrid>
              <a:tr h="491952">
                <a:tc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</a:p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/>
                          <a:ea typeface="Times New Roman"/>
                        </a:rPr>
                        <a:t>Additional file</a:t>
                      </a:r>
                      <a:r>
                        <a:rPr lang="en-US" sz="1200" b="1" baseline="0" dirty="0" smtClean="0">
                          <a:effectLst/>
                          <a:latin typeface="Times New Roman"/>
                          <a:ea typeface="Times New Roman"/>
                        </a:rPr>
                        <a:t> 1</a:t>
                      </a:r>
                      <a:r>
                        <a:rPr lang="en-US" sz="1200" b="1" dirty="0" smtClean="0">
                          <a:effectLst/>
                          <a:latin typeface="Times New Roman"/>
                          <a:ea typeface="Times New Roman"/>
                        </a:rPr>
                        <a:t>.  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</a:rPr>
                        <a:t>Primers </a:t>
                      </a: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used in gene expression analysis by qPCR to 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</a:rPr>
                        <a:t>validate RNA-</a:t>
                      </a:r>
                      <a:r>
                        <a:rPr lang="en-US" sz="1200" dirty="0" err="1" smtClean="0">
                          <a:effectLst/>
                          <a:latin typeface="Times New Roman"/>
                          <a:ea typeface="Times New Roman"/>
                        </a:rPr>
                        <a:t>seq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</a:rPr>
                        <a:t> results.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</a:p>
                  </a:txBody>
                  <a:tcPr marL="36896" marR="3689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9839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</a:rPr>
                        <a:t>Gene ID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Primer Pairs (Forward</a:t>
                      </a: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Reverse, 5’…3’)</a:t>
                      </a:r>
                    </a:p>
                  </a:txBody>
                  <a:tcPr marL="36896" marR="368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9G2416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Times New Roman"/>
                          <a:ea typeface="Times New Roman"/>
                        </a:rPr>
                        <a:t>TCACATCTTGCCTGTGTGCT</a:t>
                      </a: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 dirty="0" err="1">
                          <a:effectLst/>
                          <a:latin typeface="Times New Roman"/>
                          <a:ea typeface="Times New Roman"/>
                        </a:rPr>
                        <a:t>CGGTAATGCCATTGTCACAG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5G0175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CCCGAGATAAGAAAGCGAAA</a:t>
                      </a: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 TTGCTGAACAAAACGATGGA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1G4940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CGTGGGTATACGATGGTCAC</a:t>
                      </a: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CCCTCCTTAATTCCCCACTG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8G1122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effectLst/>
                          <a:latin typeface="Times New Roman"/>
                        </a:rPr>
                        <a:t>CGTACATGCTGCGGAGTG</a:t>
                      </a:r>
                      <a:r>
                        <a:rPr lang="en-US" sz="1200" b="1" dirty="0">
                          <a:effectLst/>
                          <a:latin typeface="Times New Roman"/>
                        </a:rPr>
                        <a:t>/</a:t>
                      </a:r>
                      <a:r>
                        <a:rPr lang="en-US" sz="1200" dirty="0">
                          <a:effectLst/>
                          <a:latin typeface="Times New Roman"/>
                        </a:rPr>
                        <a:t>ACGATGAGCTCCTCCTCCTG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2G2425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GGATCACTTGCCCCTACAAA</a:t>
                      </a: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TCTGTTGGTAAGCTGGTGGA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6G1703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ACGCAGATTCTTGCCGTACT</a:t>
                      </a: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TAGCCGTCATCCTCGCTACT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3G3008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GGTGACCAACAGCCTCAAGT</a:t>
                      </a: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TACGCGGCCTTCTTGTACTC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5G0850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GTATCGAGGGGAGGAGAACC</a:t>
                      </a: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ACTCCCACTTGGCACAGAAC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3G1198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CAAATGGTGGCATTGAACTG</a:t>
                      </a: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</a:rPr>
                        <a:t>ATTTGGAGCCATGAAACCAG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>
                          <a:effectLst/>
                          <a:latin typeface="Times New Roman"/>
                          <a:ea typeface="Times New Roman"/>
                        </a:rPr>
                        <a:t>Sobic.003G328500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GGCTATCCTGGTTGATTGGA</a:t>
                      </a: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</a:rPr>
                        <a:t>/</a:t>
                      </a: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ATAGCTGAAACGCCGACAAG</a:t>
                      </a: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35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1" dirty="0" smtClean="0">
                          <a:effectLst/>
                          <a:latin typeface="Times New Roman"/>
                          <a:ea typeface="Times New Roman"/>
                        </a:rPr>
                        <a:t>18s </a:t>
                      </a:r>
                      <a:r>
                        <a:rPr lang="en-US" sz="1200" b="1" i="1" dirty="0" err="1" smtClean="0">
                          <a:effectLst/>
                          <a:latin typeface="Times New Roman"/>
                          <a:ea typeface="Times New Roman"/>
                        </a:rPr>
                        <a:t>rRNA</a:t>
                      </a:r>
                      <a:endParaRPr lang="en-US" sz="1200" b="1" i="1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</a:rPr>
                        <a:t>ATTCTATGGGTGGTGGTGCAT/TCAAACTTCGCGGCCTAAA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36896" marR="3689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13850127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36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3:33Z</dcterms:modified>
</cp:coreProperties>
</file>